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65" d="100"/>
          <a:sy n="165" d="100"/>
        </p:scale>
        <p:origin x="1272" y="27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C4DFD2-BB86-C847-849F-BF1484F8D6BD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8DE67-1EF6-DE43-AF9F-7EE475449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720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C4DFD2-BB86-C847-849F-BF1484F8D6BD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8DE67-1EF6-DE43-AF9F-7EE475449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406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C4DFD2-BB86-C847-849F-BF1484F8D6BD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8DE67-1EF6-DE43-AF9F-7EE475449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384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C4DFD2-BB86-C847-849F-BF1484F8D6BD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8DE67-1EF6-DE43-AF9F-7EE475449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719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C4DFD2-BB86-C847-849F-BF1484F8D6BD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8DE67-1EF6-DE43-AF9F-7EE475449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540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C4DFD2-BB86-C847-849F-BF1484F8D6BD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8DE67-1EF6-DE43-AF9F-7EE475449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547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C4DFD2-BB86-C847-849F-BF1484F8D6BD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8DE67-1EF6-DE43-AF9F-7EE475449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5251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C4DFD2-BB86-C847-849F-BF1484F8D6BD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8DE67-1EF6-DE43-AF9F-7EE475449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517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C4DFD2-BB86-C847-849F-BF1484F8D6BD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8DE67-1EF6-DE43-AF9F-7EE475449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6651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C4DFD2-BB86-C847-849F-BF1484F8D6BD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8DE67-1EF6-DE43-AF9F-7EE475449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2732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C4DFD2-BB86-C847-849F-BF1484F8D6BD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8DE67-1EF6-DE43-AF9F-7EE475449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310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C4DFD2-BB86-C847-849F-BF1484F8D6BD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D8DE67-1EF6-DE43-AF9F-7EE475449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695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30481658"/>
              </p:ext>
            </p:extLst>
          </p:nvPr>
        </p:nvGraphicFramePr>
        <p:xfrm>
          <a:off x="628493" y="805455"/>
          <a:ext cx="7887014" cy="4450080"/>
        </p:xfrm>
        <a:graphic>
          <a:graphicData uri="http://schemas.openxmlformats.org/drawingml/2006/table">
            <a:tbl>
              <a:tblPr firstRow="1" bandRow="1">
                <a:effectLst/>
                <a:tableStyleId>{5940675A-B579-460E-94D1-54222C63F5DA}</a:tableStyleId>
              </a:tblPr>
              <a:tblGrid>
                <a:gridCol w="902007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02007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520750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52075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520750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1520750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 Regime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Female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Recovery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wt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/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90.61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1.20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78.75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6.16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09.28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54.83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83.95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6.55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0h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41.07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8.20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aaaa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79.42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56.62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aaaa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70.18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63.65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aaaa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5.32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82.20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aaaa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74.93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8.75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aa,b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62.51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7.21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aa,bbbb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35.64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7.04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bbbb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45.59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9.42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bbbb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hr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09.08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59.27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bbbb,c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07.65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4.78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bbbb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93.55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9.38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bbbb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04.62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3.18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bbbb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370840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 Regimen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Male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Recovery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wt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/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5.32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2.58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4.98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7.33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9.80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8.23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4.12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1.52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0h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72.56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49.71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aaaa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15.03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56.80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aaaa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79.33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52.90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aaaa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41.99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47.03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aaaa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36.87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48.35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aaaa,bbbb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30.13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51.72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aaaa,bbb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20.44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7.19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aaa,bbbb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37.48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56.43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aaaa.bbbb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hr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1.49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9.92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bbbb,cccc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40.50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5.62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bbbb,ccc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0.55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16.53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bbbb,cccc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7.03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</a:t>
                      </a: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6.18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bbbb,cccc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0" y="5491652"/>
            <a:ext cx="8195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S2 Table.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b="1" dirty="0">
                <a:latin typeface="Times New Roman"/>
                <a:cs typeface="Times New Roman"/>
              </a:rPr>
              <a:t>Comparison of </a:t>
            </a:r>
            <a:r>
              <a:rPr lang="en-US" sz="1200" b="1" dirty="0" smtClean="0">
                <a:latin typeface="Times New Roman"/>
                <a:cs typeface="Times New Roman"/>
              </a:rPr>
              <a:t>serum </a:t>
            </a:r>
            <a:r>
              <a:rPr lang="en-US" sz="1200" b="1" dirty="0" err="1">
                <a:latin typeface="Times New Roman"/>
                <a:cs typeface="Times New Roman"/>
              </a:rPr>
              <a:t>corticosterone</a:t>
            </a:r>
            <a:r>
              <a:rPr lang="en-US" sz="1200" b="1" dirty="0">
                <a:latin typeface="Times New Roman"/>
                <a:cs typeface="Times New Roman"/>
              </a:rPr>
              <a:t> </a:t>
            </a:r>
            <a:r>
              <a:rPr lang="en-US" sz="1200" b="1" dirty="0" smtClean="0">
                <a:latin typeface="Times New Roman"/>
                <a:cs typeface="Times New Roman"/>
              </a:rPr>
              <a:t>levels in </a:t>
            </a:r>
            <a:r>
              <a:rPr lang="en-US" sz="1200" b="1" dirty="0" smtClean="0">
                <a:latin typeface="Times New Roman"/>
                <a:cs typeface="Times New Roman"/>
              </a:rPr>
              <a:t>unstressed </a:t>
            </a:r>
            <a:r>
              <a:rPr lang="en-US" sz="1200" b="1" i="1" dirty="0" smtClean="0">
                <a:latin typeface="Times New Roman"/>
                <a:cs typeface="Times New Roman"/>
              </a:rPr>
              <a:t>vs. </a:t>
            </a:r>
            <a:r>
              <a:rPr lang="en-US" sz="1200" b="1" dirty="0">
                <a:latin typeface="Times New Roman"/>
                <a:cs typeface="Times New Roman"/>
              </a:rPr>
              <a:t>stressed mice. 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0" y="0"/>
            <a:ext cx="93176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latin typeface="Times New Roman"/>
                <a:cs typeface="Times New Roman"/>
              </a:rPr>
              <a:t>S2 Table</a:t>
            </a:r>
          </a:p>
        </p:txBody>
      </p:sp>
    </p:spTree>
    <p:extLst>
      <p:ext uri="{BB962C8B-B14F-4D97-AF65-F5344CB8AC3E}">
        <p14:creationId xmlns:p14="http://schemas.microsoft.com/office/powerpoint/2010/main" val="4032333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7</Words>
  <Application>Microsoft Macintosh PowerPoint</Application>
  <PresentationFormat>On-screen Show (4:3)</PresentationFormat>
  <Paragraphs>6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i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ine Sivertsen Åsrud</dc:creator>
  <cp:lastModifiedBy>Kathrine Sivertsen Åsrud</cp:lastModifiedBy>
  <cp:revision>2</cp:revision>
  <dcterms:created xsi:type="dcterms:W3CDTF">2018-03-05T13:36:19Z</dcterms:created>
  <dcterms:modified xsi:type="dcterms:W3CDTF">2018-03-05T13:37:32Z</dcterms:modified>
</cp:coreProperties>
</file>